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8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</p:sldIdLst>
  <p:sldSz cx="3419475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1" userDrawn="1">
          <p15:clr>
            <a:srgbClr val="A4A3A4"/>
          </p15:clr>
        </p15:guide>
        <p15:guide id="2" pos="107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7416" autoAdjust="0"/>
    <p:restoredTop sz="94660"/>
  </p:normalViewPr>
  <p:slideViewPr>
    <p:cSldViewPr snapToGrid="0" showGuides="1">
      <p:cViewPr varScale="1">
        <p:scale>
          <a:sx n="127" d="100"/>
          <a:sy n="127" d="100"/>
        </p:scale>
        <p:origin x="245" y="86"/>
      </p:cViewPr>
      <p:guideLst>
        <p:guide orient="horz" pos="1441"/>
        <p:guide pos="107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6461" y="748242"/>
            <a:ext cx="2906554" cy="1591733"/>
          </a:xfrm>
        </p:spPr>
        <p:txBody>
          <a:bodyPr anchor="b"/>
          <a:lstStyle>
            <a:lvl1pPr algn="ctr">
              <a:defRPr sz="22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27435" y="2401359"/>
            <a:ext cx="2564606" cy="1103841"/>
          </a:xfrm>
        </p:spPr>
        <p:txBody>
          <a:bodyPr/>
          <a:lstStyle>
            <a:lvl1pPr marL="0" indent="0" algn="ctr">
              <a:buNone/>
              <a:defRPr sz="898"/>
            </a:lvl1pPr>
            <a:lvl2pPr marL="170993" indent="0" algn="ctr">
              <a:buNone/>
              <a:defRPr sz="748"/>
            </a:lvl2pPr>
            <a:lvl3pPr marL="341986" indent="0" algn="ctr">
              <a:buNone/>
              <a:defRPr sz="673"/>
            </a:lvl3pPr>
            <a:lvl4pPr marL="512978" indent="0" algn="ctr">
              <a:buNone/>
              <a:defRPr sz="598"/>
            </a:lvl4pPr>
            <a:lvl5pPr marL="683971" indent="0" algn="ctr">
              <a:buNone/>
              <a:defRPr sz="598"/>
            </a:lvl5pPr>
            <a:lvl6pPr marL="854964" indent="0" algn="ctr">
              <a:buNone/>
              <a:defRPr sz="598"/>
            </a:lvl6pPr>
            <a:lvl7pPr marL="1025957" indent="0" algn="ctr">
              <a:buNone/>
              <a:defRPr sz="598"/>
            </a:lvl7pPr>
            <a:lvl8pPr marL="1196950" indent="0" algn="ctr">
              <a:buNone/>
              <a:defRPr sz="598"/>
            </a:lvl8pPr>
            <a:lvl9pPr marL="1367942" indent="0" algn="ctr">
              <a:buNone/>
              <a:defRPr sz="59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2504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8364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447062" y="243417"/>
            <a:ext cx="737324" cy="387455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5089" y="243417"/>
            <a:ext cx="2169229" cy="387455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554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04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3308" y="1139826"/>
            <a:ext cx="2949297" cy="1901825"/>
          </a:xfrm>
        </p:spPr>
        <p:txBody>
          <a:bodyPr anchor="b"/>
          <a:lstStyle>
            <a:lvl1pPr>
              <a:defRPr sz="22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3308" y="3059643"/>
            <a:ext cx="2949297" cy="1000125"/>
          </a:xfrm>
        </p:spPr>
        <p:txBody>
          <a:bodyPr/>
          <a:lstStyle>
            <a:lvl1pPr marL="0" indent="0">
              <a:buNone/>
              <a:defRPr sz="898">
                <a:solidFill>
                  <a:schemeClr val="tx1"/>
                </a:solidFill>
              </a:defRPr>
            </a:lvl1pPr>
            <a:lvl2pPr marL="170993" indent="0">
              <a:buNone/>
              <a:defRPr sz="748">
                <a:solidFill>
                  <a:schemeClr val="tx1">
                    <a:tint val="75000"/>
                  </a:schemeClr>
                </a:solidFill>
              </a:defRPr>
            </a:lvl2pPr>
            <a:lvl3pPr marL="341986" indent="0">
              <a:buNone/>
              <a:defRPr sz="673">
                <a:solidFill>
                  <a:schemeClr val="tx1">
                    <a:tint val="75000"/>
                  </a:schemeClr>
                </a:solidFill>
              </a:defRPr>
            </a:lvl3pPr>
            <a:lvl4pPr marL="512978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4pPr>
            <a:lvl5pPr marL="683971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5pPr>
            <a:lvl6pPr marL="854964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6pPr>
            <a:lvl7pPr marL="1025957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7pPr>
            <a:lvl8pPr marL="1196950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8pPr>
            <a:lvl9pPr marL="1367942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8931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5089" y="1217083"/>
            <a:ext cx="1453277" cy="29008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1109" y="1217083"/>
            <a:ext cx="1453277" cy="29008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436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34" y="243418"/>
            <a:ext cx="2949297" cy="88370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5535" y="1120775"/>
            <a:ext cx="1446598" cy="549275"/>
          </a:xfrm>
        </p:spPr>
        <p:txBody>
          <a:bodyPr anchor="b"/>
          <a:lstStyle>
            <a:lvl1pPr marL="0" indent="0">
              <a:buNone/>
              <a:defRPr sz="898" b="1"/>
            </a:lvl1pPr>
            <a:lvl2pPr marL="170993" indent="0">
              <a:buNone/>
              <a:defRPr sz="748" b="1"/>
            </a:lvl2pPr>
            <a:lvl3pPr marL="341986" indent="0">
              <a:buNone/>
              <a:defRPr sz="673" b="1"/>
            </a:lvl3pPr>
            <a:lvl4pPr marL="512978" indent="0">
              <a:buNone/>
              <a:defRPr sz="598" b="1"/>
            </a:lvl4pPr>
            <a:lvl5pPr marL="683971" indent="0">
              <a:buNone/>
              <a:defRPr sz="598" b="1"/>
            </a:lvl5pPr>
            <a:lvl6pPr marL="854964" indent="0">
              <a:buNone/>
              <a:defRPr sz="598" b="1"/>
            </a:lvl6pPr>
            <a:lvl7pPr marL="1025957" indent="0">
              <a:buNone/>
              <a:defRPr sz="598" b="1"/>
            </a:lvl7pPr>
            <a:lvl8pPr marL="1196950" indent="0">
              <a:buNone/>
              <a:defRPr sz="598" b="1"/>
            </a:lvl8pPr>
            <a:lvl9pPr marL="1367942" indent="0">
              <a:buNone/>
              <a:defRPr sz="59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5535" y="1670050"/>
            <a:ext cx="1446598" cy="24563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731110" y="1120775"/>
            <a:ext cx="1453722" cy="549275"/>
          </a:xfrm>
        </p:spPr>
        <p:txBody>
          <a:bodyPr anchor="b"/>
          <a:lstStyle>
            <a:lvl1pPr marL="0" indent="0">
              <a:buNone/>
              <a:defRPr sz="898" b="1"/>
            </a:lvl1pPr>
            <a:lvl2pPr marL="170993" indent="0">
              <a:buNone/>
              <a:defRPr sz="748" b="1"/>
            </a:lvl2pPr>
            <a:lvl3pPr marL="341986" indent="0">
              <a:buNone/>
              <a:defRPr sz="673" b="1"/>
            </a:lvl3pPr>
            <a:lvl4pPr marL="512978" indent="0">
              <a:buNone/>
              <a:defRPr sz="598" b="1"/>
            </a:lvl4pPr>
            <a:lvl5pPr marL="683971" indent="0">
              <a:buNone/>
              <a:defRPr sz="598" b="1"/>
            </a:lvl5pPr>
            <a:lvl6pPr marL="854964" indent="0">
              <a:buNone/>
              <a:defRPr sz="598" b="1"/>
            </a:lvl6pPr>
            <a:lvl7pPr marL="1025957" indent="0">
              <a:buNone/>
              <a:defRPr sz="598" b="1"/>
            </a:lvl7pPr>
            <a:lvl8pPr marL="1196950" indent="0">
              <a:buNone/>
              <a:defRPr sz="598" b="1"/>
            </a:lvl8pPr>
            <a:lvl9pPr marL="1367942" indent="0">
              <a:buNone/>
              <a:defRPr sz="59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731110" y="1670050"/>
            <a:ext cx="1453722" cy="24563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6355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685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8324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34" y="304800"/>
            <a:ext cx="1102870" cy="1066800"/>
          </a:xfrm>
        </p:spPr>
        <p:txBody>
          <a:bodyPr anchor="b"/>
          <a:lstStyle>
            <a:lvl1pPr>
              <a:defRPr sz="1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53722" y="658285"/>
            <a:ext cx="1731109" cy="3249083"/>
          </a:xfrm>
        </p:spPr>
        <p:txBody>
          <a:bodyPr/>
          <a:lstStyle>
            <a:lvl1pPr>
              <a:defRPr sz="1197"/>
            </a:lvl1pPr>
            <a:lvl2pPr>
              <a:defRPr sz="1047"/>
            </a:lvl2pPr>
            <a:lvl3pPr>
              <a:defRPr sz="898"/>
            </a:lvl3pPr>
            <a:lvl4pPr>
              <a:defRPr sz="748"/>
            </a:lvl4pPr>
            <a:lvl5pPr>
              <a:defRPr sz="748"/>
            </a:lvl5pPr>
            <a:lvl6pPr>
              <a:defRPr sz="748"/>
            </a:lvl6pPr>
            <a:lvl7pPr>
              <a:defRPr sz="748"/>
            </a:lvl7pPr>
            <a:lvl8pPr>
              <a:defRPr sz="748"/>
            </a:lvl8pPr>
            <a:lvl9pPr>
              <a:defRPr sz="74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5534" y="1371600"/>
            <a:ext cx="1102870" cy="2541059"/>
          </a:xfrm>
        </p:spPr>
        <p:txBody>
          <a:bodyPr/>
          <a:lstStyle>
            <a:lvl1pPr marL="0" indent="0">
              <a:buNone/>
              <a:defRPr sz="598"/>
            </a:lvl1pPr>
            <a:lvl2pPr marL="170993" indent="0">
              <a:buNone/>
              <a:defRPr sz="524"/>
            </a:lvl2pPr>
            <a:lvl3pPr marL="341986" indent="0">
              <a:buNone/>
              <a:defRPr sz="449"/>
            </a:lvl3pPr>
            <a:lvl4pPr marL="512978" indent="0">
              <a:buNone/>
              <a:defRPr sz="374"/>
            </a:lvl4pPr>
            <a:lvl5pPr marL="683971" indent="0">
              <a:buNone/>
              <a:defRPr sz="374"/>
            </a:lvl5pPr>
            <a:lvl6pPr marL="854964" indent="0">
              <a:buNone/>
              <a:defRPr sz="374"/>
            </a:lvl6pPr>
            <a:lvl7pPr marL="1025957" indent="0">
              <a:buNone/>
              <a:defRPr sz="374"/>
            </a:lvl7pPr>
            <a:lvl8pPr marL="1196950" indent="0">
              <a:buNone/>
              <a:defRPr sz="374"/>
            </a:lvl8pPr>
            <a:lvl9pPr marL="1367942" indent="0">
              <a:buNone/>
              <a:defRPr sz="37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0828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34" y="304800"/>
            <a:ext cx="1102870" cy="1066800"/>
          </a:xfrm>
        </p:spPr>
        <p:txBody>
          <a:bodyPr anchor="b"/>
          <a:lstStyle>
            <a:lvl1pPr>
              <a:defRPr sz="1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453722" y="658285"/>
            <a:ext cx="1731109" cy="3249083"/>
          </a:xfrm>
        </p:spPr>
        <p:txBody>
          <a:bodyPr anchor="t"/>
          <a:lstStyle>
            <a:lvl1pPr marL="0" indent="0">
              <a:buNone/>
              <a:defRPr sz="1197"/>
            </a:lvl1pPr>
            <a:lvl2pPr marL="170993" indent="0">
              <a:buNone/>
              <a:defRPr sz="1047"/>
            </a:lvl2pPr>
            <a:lvl3pPr marL="341986" indent="0">
              <a:buNone/>
              <a:defRPr sz="898"/>
            </a:lvl3pPr>
            <a:lvl4pPr marL="512978" indent="0">
              <a:buNone/>
              <a:defRPr sz="748"/>
            </a:lvl4pPr>
            <a:lvl5pPr marL="683971" indent="0">
              <a:buNone/>
              <a:defRPr sz="748"/>
            </a:lvl5pPr>
            <a:lvl6pPr marL="854964" indent="0">
              <a:buNone/>
              <a:defRPr sz="748"/>
            </a:lvl6pPr>
            <a:lvl7pPr marL="1025957" indent="0">
              <a:buNone/>
              <a:defRPr sz="748"/>
            </a:lvl7pPr>
            <a:lvl8pPr marL="1196950" indent="0">
              <a:buNone/>
              <a:defRPr sz="748"/>
            </a:lvl8pPr>
            <a:lvl9pPr marL="1367942" indent="0">
              <a:buNone/>
              <a:defRPr sz="74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5534" y="1371600"/>
            <a:ext cx="1102870" cy="2541059"/>
          </a:xfrm>
        </p:spPr>
        <p:txBody>
          <a:bodyPr/>
          <a:lstStyle>
            <a:lvl1pPr marL="0" indent="0">
              <a:buNone/>
              <a:defRPr sz="598"/>
            </a:lvl1pPr>
            <a:lvl2pPr marL="170993" indent="0">
              <a:buNone/>
              <a:defRPr sz="524"/>
            </a:lvl2pPr>
            <a:lvl3pPr marL="341986" indent="0">
              <a:buNone/>
              <a:defRPr sz="449"/>
            </a:lvl3pPr>
            <a:lvl4pPr marL="512978" indent="0">
              <a:buNone/>
              <a:defRPr sz="374"/>
            </a:lvl4pPr>
            <a:lvl5pPr marL="683971" indent="0">
              <a:buNone/>
              <a:defRPr sz="374"/>
            </a:lvl5pPr>
            <a:lvl6pPr marL="854964" indent="0">
              <a:buNone/>
              <a:defRPr sz="374"/>
            </a:lvl6pPr>
            <a:lvl7pPr marL="1025957" indent="0">
              <a:buNone/>
              <a:defRPr sz="374"/>
            </a:lvl7pPr>
            <a:lvl8pPr marL="1196950" indent="0">
              <a:buNone/>
              <a:defRPr sz="374"/>
            </a:lvl8pPr>
            <a:lvl9pPr marL="1367942" indent="0">
              <a:buNone/>
              <a:defRPr sz="37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7090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35089" y="243418"/>
            <a:ext cx="2949297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5089" y="1217083"/>
            <a:ext cx="2949297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35089" y="4237568"/>
            <a:ext cx="769382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0A32BB-1EBA-468C-8A0E-444A99DFF434}" type="datetimeFigureOut">
              <a:rPr lang="zh-CN" altLang="en-US" smtClean="0"/>
              <a:t>2020/1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32701" y="4237568"/>
            <a:ext cx="1154073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415004" y="4237568"/>
            <a:ext cx="769382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5664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41986" rtl="0" eaLnBrk="1" latinLnBrk="0" hangingPunct="1">
        <a:lnSpc>
          <a:spcPct val="90000"/>
        </a:lnSpc>
        <a:spcBef>
          <a:spcPct val="0"/>
        </a:spcBef>
        <a:buNone/>
        <a:defRPr sz="16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5496" indent="-85496" algn="l" defTabSz="341986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047" kern="1200">
          <a:solidFill>
            <a:schemeClr val="tx1"/>
          </a:solidFill>
          <a:latin typeface="+mn-lt"/>
          <a:ea typeface="+mn-ea"/>
          <a:cs typeface="+mn-cs"/>
        </a:defRPr>
      </a:lvl1pPr>
      <a:lvl2pPr marL="256489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898" kern="1200">
          <a:solidFill>
            <a:schemeClr val="tx1"/>
          </a:solidFill>
          <a:latin typeface="+mn-lt"/>
          <a:ea typeface="+mn-ea"/>
          <a:cs typeface="+mn-cs"/>
        </a:defRPr>
      </a:lvl2pPr>
      <a:lvl3pPr marL="427482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748" kern="1200">
          <a:solidFill>
            <a:schemeClr val="tx1"/>
          </a:solidFill>
          <a:latin typeface="+mn-lt"/>
          <a:ea typeface="+mn-ea"/>
          <a:cs typeface="+mn-cs"/>
        </a:defRPr>
      </a:lvl3pPr>
      <a:lvl4pPr marL="598475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4pPr>
      <a:lvl5pPr marL="769468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5pPr>
      <a:lvl6pPr marL="940460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6pPr>
      <a:lvl7pPr marL="1111453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7pPr>
      <a:lvl8pPr marL="1282446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8pPr>
      <a:lvl9pPr marL="1453439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1pPr>
      <a:lvl2pPr marL="170993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2pPr>
      <a:lvl3pPr marL="341986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3pPr>
      <a:lvl4pPr marL="512978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4pPr>
      <a:lvl5pPr marL="683971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5pPr>
      <a:lvl6pPr marL="854964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6pPr>
      <a:lvl7pPr marL="1025957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7pPr>
      <a:lvl8pPr marL="1196950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8pPr>
      <a:lvl9pPr marL="1367942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ti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7182DBB-9462-482F-A2AD-B580B73C9D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5065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6D7F83C-77CA-49B7-B7DE-FCEA3B04BF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22571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86BB8F0-CF0C-4971-B852-C27C25EB28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310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87632B0-2F65-4AFB-AE49-8009C8EFA8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63855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F2E64BE-FCA7-4E53-86A0-B66C6B7C81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097084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1309C4E-2B65-43AC-9F70-23146C8AFD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98025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7800045-4FFB-4560-846D-97CFF7D406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469282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FEE497B-876D-435A-A02F-7CECBDB018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693293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7DAA1A2-EB9E-42C4-82A9-58FF0419E8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346465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4BAE7FB-1285-4F5C-AE25-222DA58716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772419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B2C37C2-778B-4F9E-94A9-C43FCACCEF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78885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8965CF2-A89D-468B-B946-D32D6E64B5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854472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D3762FA-7C50-43A8-92E6-587146EC52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109596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51A82370-2D6F-47E4-A37E-BA2E8430A5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333841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5FF24B1-B048-4FB1-8A60-3DC2622F7E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535134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C33F4D0-1A43-4262-9556-208819707E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748655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45C220E-10DF-4398-ACF0-5C8D75F31C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349168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166C2D2-1249-4E44-81E0-6F3D0C650B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497580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F4AEB27-F5E7-4CDF-861C-3B83BB3E72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31569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F755549-ECAC-4093-B1EF-07B121AC99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626564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8C61FBE-9046-4C30-BF19-071F3C45B5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969570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A2A9787-B131-4FD2-9071-278F496835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14337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E47ABE3-8756-4F9E-A032-B2D32BD1D8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8609084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DC3A95E-35E2-4CE4-AB69-1F811E7E7A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85725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13416F8-C4D1-4A68-A9DC-30B4A13BC5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11913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2CEE64D-A3A1-43BF-A1E8-D269C47D09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4876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E35DE32-A6BF-4E59-B819-DE515D7D85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21882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3651D02-ABEF-4F70-B382-74E27EF850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0770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E73528C-DEE5-40D8-A836-DDCF30F8B6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65345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10D27FE-729A-4DBE-86DE-9E3D7BBC35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3903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0</Words>
  <Application>Microsoft Office PowerPoint</Application>
  <PresentationFormat>自定义</PresentationFormat>
  <Paragraphs>0</Paragraphs>
  <Slides>3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0</vt:i4>
      </vt:variant>
    </vt:vector>
  </HeadingPairs>
  <TitlesOfParts>
    <vt:vector size="34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胡 庭筠</dc:creator>
  <cp:lastModifiedBy>胡 庭筠</cp:lastModifiedBy>
  <cp:revision>5</cp:revision>
  <dcterms:created xsi:type="dcterms:W3CDTF">2020-01-15T11:31:36Z</dcterms:created>
  <dcterms:modified xsi:type="dcterms:W3CDTF">2020-01-16T17:16:15Z</dcterms:modified>
</cp:coreProperties>
</file>